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9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6"/>
  </p:normalViewPr>
  <p:slideViewPr>
    <p:cSldViewPr snapToGrid="0" snapToObjects="1">
      <p:cViewPr varScale="1">
        <p:scale>
          <a:sx n="108" d="100"/>
          <a:sy n="108" d="100"/>
        </p:scale>
        <p:origin x="7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41C5B74-927B-6645-9700-D2131674D8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A62F886A-4942-B348-A2E2-03134BB0C7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823DE2C-0C90-B84B-9122-824173DEF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1DE0A-417B-8540-9E04-2FC4084E2D2A}" type="datetimeFigureOut">
              <a:rPr lang="it-IT" smtClean="0"/>
              <a:t>21/12/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B3D2C0D-2FC4-BA4A-9BC0-33331DD32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F13BAD0-C331-FF4B-B3B5-E6864B1EAA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8BC7-CEE1-EF47-8F26-983CCA7C2A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57290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DC620D9-E6E0-6F4D-B465-446FB40745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3973C2C6-B775-3545-B3D8-824A374636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00A5AAB-F744-5843-B029-3EDF5068F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1DE0A-417B-8540-9E04-2FC4084E2D2A}" type="datetimeFigureOut">
              <a:rPr lang="it-IT" smtClean="0"/>
              <a:t>21/12/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EC11329-1470-C04B-AB77-90004C1652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16C5528-996D-124B-8935-B5B753E4CD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8BC7-CEE1-EF47-8F26-983CCA7C2A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53126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CFC90159-FABD-0744-B7BE-7088F8054F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A4A0A0A-E829-2E4A-9412-D7C331CC94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32C64D9-63F6-2E4B-A896-D5A118BDE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1DE0A-417B-8540-9E04-2FC4084E2D2A}" type="datetimeFigureOut">
              <a:rPr lang="it-IT" smtClean="0"/>
              <a:t>21/12/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39821D5-DEE1-4F4B-AB27-714C25CCBF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C38560A-2DF2-3442-9C21-357455A0E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8BC7-CEE1-EF47-8F26-983CCA7C2A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24455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03C490-22BC-7E4C-921F-9809B57EE4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F1A7DA7-744F-1C4A-88A0-00594E6B10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4232E5D-9BFA-1B4A-A344-8554A8836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1DE0A-417B-8540-9E04-2FC4084E2D2A}" type="datetimeFigureOut">
              <a:rPr lang="it-IT" smtClean="0"/>
              <a:t>21/12/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2F5A408-1D19-124D-8D3E-7CA15DC9EE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0DD8006-C6FC-2744-A063-0DA04CDF3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8BC7-CEE1-EF47-8F26-983CCA7C2A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02066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CA87D04-926E-6049-8B39-A512736EC0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4D48A85-016B-9E4D-BD28-397A96B0CF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2CA5683-C240-AD46-8777-39CD1A4EF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1DE0A-417B-8540-9E04-2FC4084E2D2A}" type="datetimeFigureOut">
              <a:rPr lang="it-IT" smtClean="0"/>
              <a:t>21/12/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E081442-0C0B-3349-BFD1-A44F001D30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F9F2AF2-DCBB-B142-AA3B-B6B95EC610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8BC7-CEE1-EF47-8F26-983CCA7C2A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1116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C6A5DBE-D16B-2041-AACD-92BFF8C7EB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40502EE-F477-BE4B-81B0-BD5EAAF1F2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71EF42C-37F7-7C4D-B543-4C2AC41A61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241CB4F-6EBE-C141-A8CB-6DC5A26F43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1DE0A-417B-8540-9E04-2FC4084E2D2A}" type="datetimeFigureOut">
              <a:rPr lang="it-IT" smtClean="0"/>
              <a:t>21/12/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CD33932-1DB8-B041-9039-93A75ACD2E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DEA830B-E8B1-BC46-87D1-3277751E9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8BC7-CEE1-EF47-8F26-983CCA7C2A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57073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BC765F0-CA40-2D46-ABC5-2546C6181C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6F2450A-0915-4948-89F5-941209858F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A37853D-0F0D-0F4B-A886-7F648796F5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2D020783-703A-8B4C-89FB-7291466092F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7BF92B0-8010-C14A-BD20-E0B67B48C8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B6775BBF-7890-5F4B-81D1-CB03E7526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1DE0A-417B-8540-9E04-2FC4084E2D2A}" type="datetimeFigureOut">
              <a:rPr lang="it-IT" smtClean="0"/>
              <a:t>21/12/20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E1B1C639-6035-F549-B8B9-161B590ECD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4349A919-ACE0-A54D-AE28-2629226993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8BC7-CEE1-EF47-8F26-983CCA7C2A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397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38AEBC-9D32-AC49-A419-FC3D942E95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3922B8B1-DF0A-3645-B03F-5E97BD9282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1DE0A-417B-8540-9E04-2FC4084E2D2A}" type="datetimeFigureOut">
              <a:rPr lang="it-IT" smtClean="0"/>
              <a:t>21/12/20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123AE587-13CF-DE47-8F0C-C6783094E5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FA0BA82-9DCB-B940-A87E-457224854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8BC7-CEE1-EF47-8F26-983CCA7C2A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1051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0DC91E3-EE72-C040-AB57-E91E8465D8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1DE0A-417B-8540-9E04-2FC4084E2D2A}" type="datetimeFigureOut">
              <a:rPr lang="it-IT" smtClean="0"/>
              <a:t>21/12/20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7715D3E2-A96A-1143-9CF8-7B064BE3C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1873A489-A8B1-6848-AA3D-465D4BA53A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8BC7-CEE1-EF47-8F26-983CCA7C2A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1605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8003F70-5629-FB4F-A407-8DA7BB9292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27B3280-1CC5-E54C-A51B-ADEA6C2D05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BBAB2DA-77D4-5445-8530-BA5F424496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0DA9F74-4DB7-6544-9D55-BFA79CEEDE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1DE0A-417B-8540-9E04-2FC4084E2D2A}" type="datetimeFigureOut">
              <a:rPr lang="it-IT" smtClean="0"/>
              <a:t>21/12/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5F2722D-2E81-F348-B984-AD93707D2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97DB2ED-D316-6B4B-9D3A-03E54BA726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8BC7-CEE1-EF47-8F26-983CCA7C2A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7582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03081CE-BEC1-D945-9C0F-6739CB94D3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F03ED3F-DAD6-9846-B46E-6DA5BE1EE2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7FEE856-5487-634E-A9A1-B13E79FCB3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CDA4737-DFDD-DA40-8B06-C9815AD6D1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31DE0A-417B-8540-9E04-2FC4084E2D2A}" type="datetimeFigureOut">
              <a:rPr lang="it-IT" smtClean="0"/>
              <a:t>21/12/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6DE0D96-DB1A-7645-999C-1C87D5B47A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7A9A844-435C-C94C-A6BB-2A5D4BC547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408BC7-CEE1-EF47-8F26-983CCA7C2A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954396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CDC1171-0AC3-6744-BA3B-788EE8227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1740DAF-5F9A-F142-ADE9-69A687FC03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44ADEBF-B715-9949-B57C-531F591EB4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31DE0A-417B-8540-9E04-2FC4084E2D2A}" type="datetimeFigureOut">
              <a:rPr lang="it-IT" smtClean="0"/>
              <a:t>21/12/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50EFB40-6D01-784F-8B8E-5888408FFD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ED832C9-F781-2449-937E-1AFCD84B91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408BC7-CEE1-EF47-8F26-983CCA7C2A3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75145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uppo 10">
            <a:extLst>
              <a:ext uri="{FF2B5EF4-FFF2-40B4-BE49-F238E27FC236}">
                <a16:creationId xmlns:a16="http://schemas.microsoft.com/office/drawing/2014/main" id="{F192BE93-6BC8-144B-A56A-D69544F0DC59}"/>
              </a:ext>
            </a:extLst>
          </p:cNvPr>
          <p:cNvGrpSpPr/>
          <p:nvPr/>
        </p:nvGrpSpPr>
        <p:grpSpPr>
          <a:xfrm>
            <a:off x="543213" y="279748"/>
            <a:ext cx="2988850" cy="2001799"/>
            <a:chOff x="543213" y="279748"/>
            <a:chExt cx="2988850" cy="2001799"/>
          </a:xfrm>
        </p:grpSpPr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68F507DE-29BA-DE42-9A3C-2236400C3BF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43213" y="681347"/>
              <a:ext cx="2959100" cy="1600200"/>
            </a:xfrm>
            <a:prstGeom prst="rect">
              <a:avLst/>
            </a:prstGeom>
          </p:spPr>
        </p:pic>
        <p:sp>
          <p:nvSpPr>
            <p:cNvPr id="5" name="Rettangolo 4">
              <a:extLst>
                <a:ext uri="{FF2B5EF4-FFF2-40B4-BE49-F238E27FC236}">
                  <a16:creationId xmlns:a16="http://schemas.microsoft.com/office/drawing/2014/main" id="{BC75B769-40FB-7845-B3C9-7C889E8AF35F}"/>
                </a:ext>
              </a:extLst>
            </p:cNvPr>
            <p:cNvSpPr/>
            <p:nvPr/>
          </p:nvSpPr>
          <p:spPr>
            <a:xfrm>
              <a:off x="1698170" y="1852551"/>
              <a:ext cx="760022" cy="28500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" name="Rettangolo 5">
              <a:extLst>
                <a:ext uri="{FF2B5EF4-FFF2-40B4-BE49-F238E27FC236}">
                  <a16:creationId xmlns:a16="http://schemas.microsoft.com/office/drawing/2014/main" id="{7F69474F-6145-034A-BEBF-97999C16CFB3}"/>
                </a:ext>
              </a:extLst>
            </p:cNvPr>
            <p:cNvSpPr/>
            <p:nvPr/>
          </p:nvSpPr>
          <p:spPr>
            <a:xfrm>
              <a:off x="700642" y="1852551"/>
              <a:ext cx="760022" cy="28500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" name="Rettangolo 6">
              <a:extLst>
                <a:ext uri="{FF2B5EF4-FFF2-40B4-BE49-F238E27FC236}">
                  <a16:creationId xmlns:a16="http://schemas.microsoft.com/office/drawing/2014/main" id="{1EC6E83D-9483-7D4E-8F9B-2B30D63E1B75}"/>
                </a:ext>
              </a:extLst>
            </p:cNvPr>
            <p:cNvSpPr/>
            <p:nvPr/>
          </p:nvSpPr>
          <p:spPr>
            <a:xfrm>
              <a:off x="2599785" y="1852551"/>
              <a:ext cx="760022" cy="28500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CFEFE917-205F-C74A-B63F-3F65F43D71EE}"/>
                </a:ext>
              </a:extLst>
            </p:cNvPr>
            <p:cNvSpPr txBox="1"/>
            <p:nvPr/>
          </p:nvSpPr>
          <p:spPr>
            <a:xfrm>
              <a:off x="1600213" y="464414"/>
              <a:ext cx="8451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Immune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E53F3B04-569B-154B-9A7B-364F6D112D63}"/>
                </a:ext>
              </a:extLst>
            </p:cNvPr>
            <p:cNvSpPr txBox="1"/>
            <p:nvPr/>
          </p:nvSpPr>
          <p:spPr>
            <a:xfrm>
              <a:off x="543213" y="279748"/>
              <a:ext cx="9975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re</a:t>
              </a:r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-immune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7E029CD6-53DB-A74B-9743-006E9537AFFC}"/>
                </a:ext>
              </a:extLst>
            </p:cNvPr>
            <p:cNvSpPr txBox="1"/>
            <p:nvPr/>
          </p:nvSpPr>
          <p:spPr>
            <a:xfrm>
              <a:off x="2363374" y="434381"/>
              <a:ext cx="1168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it-IT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mmunogen</a:t>
              </a:r>
              <a:endParaRPr lang="it-IT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EE0892E6-A6DF-C743-AF74-B236C42811D5}"/>
              </a:ext>
            </a:extLst>
          </p:cNvPr>
          <p:cNvSpPr txBox="1"/>
          <p:nvPr/>
        </p:nvSpPr>
        <p:spPr>
          <a:xfrm>
            <a:off x="5076" y="6536677"/>
            <a:ext cx="23687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ppendix Figure S1</a:t>
            </a:r>
            <a:endParaRPr lang="it-IT" sz="1400" dirty="0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C91A0B94-F9F5-774E-A4D1-AA748B79A9E1}"/>
              </a:ext>
            </a:extLst>
          </p:cNvPr>
          <p:cNvSpPr txBox="1"/>
          <p:nvPr/>
        </p:nvSpPr>
        <p:spPr>
          <a:xfrm>
            <a:off x="192192" y="310525"/>
            <a:ext cx="3510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21070591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po 11">
            <a:extLst>
              <a:ext uri="{FF2B5EF4-FFF2-40B4-BE49-F238E27FC236}">
                <a16:creationId xmlns:a16="http://schemas.microsoft.com/office/drawing/2014/main" id="{10DDFBBC-2963-144A-ACB8-6BA41D344B55}"/>
              </a:ext>
            </a:extLst>
          </p:cNvPr>
          <p:cNvGrpSpPr/>
          <p:nvPr/>
        </p:nvGrpSpPr>
        <p:grpSpPr>
          <a:xfrm>
            <a:off x="338740" y="538265"/>
            <a:ext cx="4008226" cy="2890735"/>
            <a:chOff x="338740" y="538265"/>
            <a:chExt cx="4008226" cy="2890735"/>
          </a:xfrm>
        </p:grpSpPr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2ABACD62-48B4-1F49-BCB4-8F1E379C336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61736" y="538265"/>
              <a:ext cx="2908300" cy="1435100"/>
            </a:xfrm>
            <a:prstGeom prst="rect">
              <a:avLst/>
            </a:prstGeom>
          </p:spPr>
        </p:pic>
        <p:sp>
          <p:nvSpPr>
            <p:cNvPr id="5" name="Rettangolo 4">
              <a:extLst>
                <a:ext uri="{FF2B5EF4-FFF2-40B4-BE49-F238E27FC236}">
                  <a16:creationId xmlns:a16="http://schemas.microsoft.com/office/drawing/2014/main" id="{0B123CDF-24AD-7E4A-8494-5555EE6F1C02}"/>
                </a:ext>
              </a:extLst>
            </p:cNvPr>
            <p:cNvSpPr/>
            <p:nvPr/>
          </p:nvSpPr>
          <p:spPr>
            <a:xfrm>
              <a:off x="676890" y="712519"/>
              <a:ext cx="1116000" cy="252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" name="Rettangolo 5">
              <a:extLst>
                <a:ext uri="{FF2B5EF4-FFF2-40B4-BE49-F238E27FC236}">
                  <a16:creationId xmlns:a16="http://schemas.microsoft.com/office/drawing/2014/main" id="{062C6144-3CE7-A349-971C-3D52B950AA5E}"/>
                </a:ext>
              </a:extLst>
            </p:cNvPr>
            <p:cNvSpPr/>
            <p:nvPr/>
          </p:nvSpPr>
          <p:spPr>
            <a:xfrm>
              <a:off x="1792890" y="712519"/>
              <a:ext cx="1484700" cy="25200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7" name="Immagine 6">
              <a:extLst>
                <a:ext uri="{FF2B5EF4-FFF2-40B4-BE49-F238E27FC236}">
                  <a16:creationId xmlns:a16="http://schemas.microsoft.com/office/drawing/2014/main" id="{8AAB75B9-F197-F641-95AC-E586CD93E00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8740" y="1993900"/>
              <a:ext cx="2908300" cy="1435100"/>
            </a:xfrm>
            <a:prstGeom prst="rect">
              <a:avLst/>
            </a:prstGeom>
          </p:spPr>
        </p:pic>
        <p:sp>
          <p:nvSpPr>
            <p:cNvPr id="8" name="Rettangolo 7">
              <a:extLst>
                <a:ext uri="{FF2B5EF4-FFF2-40B4-BE49-F238E27FC236}">
                  <a16:creationId xmlns:a16="http://schemas.microsoft.com/office/drawing/2014/main" id="{7EC5E377-103A-6341-BB73-05910A5E2C43}"/>
                </a:ext>
              </a:extLst>
            </p:cNvPr>
            <p:cNvSpPr/>
            <p:nvPr/>
          </p:nvSpPr>
          <p:spPr>
            <a:xfrm>
              <a:off x="1792890" y="2111994"/>
              <a:ext cx="1454150" cy="25041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9" name="Rettangolo 8">
              <a:extLst>
                <a:ext uri="{FF2B5EF4-FFF2-40B4-BE49-F238E27FC236}">
                  <a16:creationId xmlns:a16="http://schemas.microsoft.com/office/drawing/2014/main" id="{1171A076-754A-0244-8FCD-273F21716EE7}"/>
                </a:ext>
              </a:extLst>
            </p:cNvPr>
            <p:cNvSpPr/>
            <p:nvPr/>
          </p:nvSpPr>
          <p:spPr>
            <a:xfrm>
              <a:off x="676890" y="2111994"/>
              <a:ext cx="1116000" cy="25041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0" name="CasellaDiTesto 103">
              <a:extLst>
                <a:ext uri="{FF2B5EF4-FFF2-40B4-BE49-F238E27FC236}">
                  <a16:creationId xmlns:a16="http://schemas.microsoft.com/office/drawing/2014/main" id="{8C01D00D-D20E-E348-896D-FD16F63FC4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0036" y="964519"/>
              <a:ext cx="976930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buFont typeface="Arial" panose="020B0604020202020204" pitchFamily="34" charset="0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pPr eaLnBrk="1" hangingPunct="1"/>
              <a:r>
                <a:rPr lang="it-IT" altLang="zh-CN" sz="1200" dirty="0">
                  <a:solidFill>
                    <a:srgbClr val="000000"/>
                  </a:solidFill>
                  <a:sym typeface="Arial" panose="020B0604020202020204" pitchFamily="34" charset="0"/>
                </a:rPr>
                <a:t>GFP-TBC1D31</a:t>
              </a:r>
              <a:endParaRPr lang="it-IT" altLang="zh-CN" dirty="0"/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8A942A8F-0E64-0E4E-8D4E-6FEDBDA2BBF5}"/>
                </a:ext>
              </a:extLst>
            </p:cNvPr>
            <p:cNvSpPr txBox="1"/>
            <p:nvPr/>
          </p:nvSpPr>
          <p:spPr>
            <a:xfrm>
              <a:off x="3319817" y="2434451"/>
              <a:ext cx="5386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flag</a:t>
              </a:r>
            </a:p>
          </p:txBody>
        </p:sp>
      </p:grp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1F384E82-748B-3743-AD0C-005A480E7EEA}"/>
              </a:ext>
            </a:extLst>
          </p:cNvPr>
          <p:cNvSpPr txBox="1"/>
          <p:nvPr/>
        </p:nvSpPr>
        <p:spPr>
          <a:xfrm>
            <a:off x="5076" y="6536677"/>
            <a:ext cx="23687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ppendix Figure S4</a:t>
            </a:r>
            <a:endParaRPr lang="it-IT" sz="1400" dirty="0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43D2AA89-09C2-4042-A28B-51D28B2AC978}"/>
              </a:ext>
            </a:extLst>
          </p:cNvPr>
          <p:cNvSpPr txBox="1"/>
          <p:nvPr/>
        </p:nvSpPr>
        <p:spPr>
          <a:xfrm>
            <a:off x="192192" y="310525"/>
            <a:ext cx="3510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16611488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D13BFD55-7E67-0E47-AB25-7EAC5DBEDE04}"/>
              </a:ext>
            </a:extLst>
          </p:cNvPr>
          <p:cNvSpPr txBox="1"/>
          <p:nvPr/>
        </p:nvSpPr>
        <p:spPr>
          <a:xfrm>
            <a:off x="5076" y="6536677"/>
            <a:ext cx="23687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ppendix Figure S5</a:t>
            </a:r>
            <a:endParaRPr lang="it-IT" sz="1400" dirty="0"/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65145061-34A1-D04E-99D3-8672C8C76C95}"/>
              </a:ext>
            </a:extLst>
          </p:cNvPr>
          <p:cNvSpPr txBox="1"/>
          <p:nvPr/>
        </p:nvSpPr>
        <p:spPr>
          <a:xfrm>
            <a:off x="737823" y="570271"/>
            <a:ext cx="3510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it-IT" sz="1400" dirty="0"/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48AA8295-12FA-A14F-9C8C-47ED3F1A2BE1}"/>
              </a:ext>
            </a:extLst>
          </p:cNvPr>
          <p:cNvSpPr txBox="1"/>
          <p:nvPr/>
        </p:nvSpPr>
        <p:spPr>
          <a:xfrm>
            <a:off x="6279741" y="570272"/>
            <a:ext cx="3510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it-IT" sz="1400" dirty="0"/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ACEABFBD-206D-0942-B372-3310413DAF6F}"/>
              </a:ext>
            </a:extLst>
          </p:cNvPr>
          <p:cNvGrpSpPr/>
          <p:nvPr/>
        </p:nvGrpSpPr>
        <p:grpSpPr>
          <a:xfrm>
            <a:off x="1859560" y="1519315"/>
            <a:ext cx="3997802" cy="1710732"/>
            <a:chOff x="1859560" y="1519315"/>
            <a:chExt cx="3997802" cy="1710732"/>
          </a:xfrm>
        </p:grpSpPr>
        <p:pic>
          <p:nvPicPr>
            <p:cNvPr id="7" name="Immagine 6" descr="Immagine che contiene screenshot&#10;&#10;Descrizione generata automaticamente">
              <a:extLst>
                <a:ext uri="{FF2B5EF4-FFF2-40B4-BE49-F238E27FC236}">
                  <a16:creationId xmlns:a16="http://schemas.microsoft.com/office/drawing/2014/main" id="{073A875A-B0AF-4309-91F7-0EAED68A00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20" t="23290" r="14778" b="55942"/>
            <a:stretch/>
          </p:blipFill>
          <p:spPr>
            <a:xfrm>
              <a:off x="1859560" y="1519315"/>
              <a:ext cx="3338818" cy="696286"/>
            </a:xfrm>
            <a:prstGeom prst="rect">
              <a:avLst/>
            </a:prstGeom>
          </p:spPr>
        </p:pic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0E67BD69-FB05-42F1-84A5-602616763FB3}"/>
                </a:ext>
              </a:extLst>
            </p:cNvPr>
            <p:cNvSpPr txBox="1"/>
            <p:nvPr/>
          </p:nvSpPr>
          <p:spPr>
            <a:xfrm>
              <a:off x="5238535" y="2709785"/>
              <a:ext cx="5786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sym typeface="Symbol" pitchFamily="2" charset="2"/>
                </a:rPr>
                <a:t>-</a:t>
              </a:r>
              <a:r>
                <a:rPr lang="it-IT" sz="1000" dirty="0">
                  <a:latin typeface="Helvetica" charset="0"/>
                  <a:sym typeface="Symbol" pitchFamily="2" charset="2"/>
                </a:rPr>
                <a:t>ACT</a:t>
              </a:r>
              <a:endParaRPr lang="it-IT" sz="10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C4EB322A-21CC-4669-88D6-8161CE073373}"/>
                </a:ext>
              </a:extLst>
            </p:cNvPr>
            <p:cNvSpPr txBox="1"/>
            <p:nvPr/>
          </p:nvSpPr>
          <p:spPr>
            <a:xfrm>
              <a:off x="5198379" y="1756945"/>
              <a:ext cx="6589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ea typeface="Helvetica" charset="0"/>
                  <a:cs typeface="Arial" panose="020B0604020202020204" pitchFamily="34" charset="0"/>
                </a:rPr>
                <a:t>OFD1</a:t>
              </a:r>
            </a:p>
          </p:txBody>
        </p:sp>
        <p:pic>
          <p:nvPicPr>
            <p:cNvPr id="28" name="Immagine 27">
              <a:extLst>
                <a:ext uri="{FF2B5EF4-FFF2-40B4-BE49-F238E27FC236}">
                  <a16:creationId xmlns:a16="http://schemas.microsoft.com/office/drawing/2014/main" id="{101350F5-BFBB-42CD-8C29-995CE73578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2320" t="58958" r="11470" b="21252"/>
            <a:stretch/>
          </p:blipFill>
          <p:spPr>
            <a:xfrm>
              <a:off x="1859560" y="2232109"/>
              <a:ext cx="3338819" cy="997938"/>
            </a:xfrm>
            <a:prstGeom prst="rect">
              <a:avLst/>
            </a:prstGeom>
          </p:spPr>
        </p:pic>
        <p:sp>
          <p:nvSpPr>
            <p:cNvPr id="33" name="Rettangolo 32">
              <a:extLst>
                <a:ext uri="{FF2B5EF4-FFF2-40B4-BE49-F238E27FC236}">
                  <a16:creationId xmlns:a16="http://schemas.microsoft.com/office/drawing/2014/main" id="{985BA0C8-F839-AF4D-BA62-FC12B6D5E159}"/>
                </a:ext>
              </a:extLst>
            </p:cNvPr>
            <p:cNvSpPr/>
            <p:nvPr/>
          </p:nvSpPr>
          <p:spPr>
            <a:xfrm>
              <a:off x="1895633" y="2808619"/>
              <a:ext cx="3043388" cy="29843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4" name="Rettangolo 33">
              <a:extLst>
                <a:ext uri="{FF2B5EF4-FFF2-40B4-BE49-F238E27FC236}">
                  <a16:creationId xmlns:a16="http://schemas.microsoft.com/office/drawing/2014/main" id="{1CB529FB-8875-2941-B2C9-2E17356E4D27}"/>
                </a:ext>
              </a:extLst>
            </p:cNvPr>
            <p:cNvSpPr/>
            <p:nvPr/>
          </p:nvSpPr>
          <p:spPr>
            <a:xfrm>
              <a:off x="1971650" y="1784140"/>
              <a:ext cx="3043388" cy="29843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4" name="Gruppo 3">
            <a:extLst>
              <a:ext uri="{FF2B5EF4-FFF2-40B4-BE49-F238E27FC236}">
                <a16:creationId xmlns:a16="http://schemas.microsoft.com/office/drawing/2014/main" id="{C2044CAB-0699-DE45-9BF1-53573699B899}"/>
              </a:ext>
            </a:extLst>
          </p:cNvPr>
          <p:cNvGrpSpPr/>
          <p:nvPr/>
        </p:nvGrpSpPr>
        <p:grpSpPr>
          <a:xfrm>
            <a:off x="6731502" y="1486130"/>
            <a:ext cx="3060053" cy="2549736"/>
            <a:chOff x="6731502" y="1486130"/>
            <a:chExt cx="3060053" cy="2549736"/>
          </a:xfrm>
        </p:grpSpPr>
        <p:pic>
          <p:nvPicPr>
            <p:cNvPr id="31" name="Immagine 30">
              <a:extLst>
                <a:ext uri="{FF2B5EF4-FFF2-40B4-BE49-F238E27FC236}">
                  <a16:creationId xmlns:a16="http://schemas.microsoft.com/office/drawing/2014/main" id="{97692337-42F3-4754-B16C-4C7F2AFAD73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731504" y="1486130"/>
              <a:ext cx="2418297" cy="381328"/>
            </a:xfrm>
            <a:prstGeom prst="rect">
              <a:avLst/>
            </a:prstGeom>
          </p:spPr>
        </p:pic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id="{4A5D20F7-07F4-483C-ACEA-D542F6E966CE}"/>
                </a:ext>
              </a:extLst>
            </p:cNvPr>
            <p:cNvSpPr txBox="1"/>
            <p:nvPr/>
          </p:nvSpPr>
          <p:spPr>
            <a:xfrm>
              <a:off x="9105385" y="1551936"/>
              <a:ext cx="6589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latin typeface="Arial" panose="020B0604020202020204" pitchFamily="34" charset="0"/>
                  <a:ea typeface="Helvetica" charset="0"/>
                  <a:cs typeface="Arial" panose="020B0604020202020204" pitchFamily="34" charset="0"/>
                </a:rPr>
                <a:t>praja2</a:t>
              </a:r>
            </a:p>
          </p:txBody>
        </p:sp>
        <p:sp>
          <p:nvSpPr>
            <p:cNvPr id="42" name="CasellaDiTesto 41">
              <a:extLst>
                <a:ext uri="{FF2B5EF4-FFF2-40B4-BE49-F238E27FC236}">
                  <a16:creationId xmlns:a16="http://schemas.microsoft.com/office/drawing/2014/main" id="{39E65200-E391-40F9-AC37-3F7259DBBFA2}"/>
                </a:ext>
              </a:extLst>
            </p:cNvPr>
            <p:cNvSpPr txBox="1"/>
            <p:nvPr/>
          </p:nvSpPr>
          <p:spPr>
            <a:xfrm>
              <a:off x="9155019" y="2722426"/>
              <a:ext cx="6365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dirty="0">
                  <a:sym typeface="Symbol" pitchFamily="2" charset="2"/>
                </a:rPr>
                <a:t>-</a:t>
              </a:r>
              <a:r>
                <a:rPr lang="it-IT" sz="1200" dirty="0">
                  <a:latin typeface="Helvetica" charset="0"/>
                  <a:sym typeface="Symbol" pitchFamily="2" charset="2"/>
                </a:rPr>
                <a:t>ACT</a:t>
              </a:r>
              <a:endParaRPr lang="it-IT" sz="1200" dirty="0">
                <a:latin typeface="Helvetica" charset="0"/>
                <a:ea typeface="Helvetica" charset="0"/>
                <a:cs typeface="Helvetica" charset="0"/>
              </a:endParaRPr>
            </a:p>
          </p:txBody>
        </p:sp>
        <p:pic>
          <p:nvPicPr>
            <p:cNvPr id="49" name="Immagine 48">
              <a:extLst>
                <a:ext uri="{FF2B5EF4-FFF2-40B4-BE49-F238E27FC236}">
                  <a16:creationId xmlns:a16="http://schemas.microsoft.com/office/drawing/2014/main" id="{F39B0327-946F-4875-98FE-A757C284F75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731503" y="1914261"/>
              <a:ext cx="2412963" cy="764547"/>
            </a:xfrm>
            <a:prstGeom prst="rect">
              <a:avLst/>
            </a:prstGeom>
          </p:spPr>
        </p:pic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28F366D0-8F73-4ECD-BC84-5BCBDA8C1370}"/>
                </a:ext>
              </a:extLst>
            </p:cNvPr>
            <p:cNvSpPr txBox="1"/>
            <p:nvPr/>
          </p:nvSpPr>
          <p:spPr>
            <a:xfrm>
              <a:off x="9105385" y="2180353"/>
              <a:ext cx="6589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ea typeface="Helvetica" charset="0"/>
                  <a:cs typeface="Arial" panose="020B0604020202020204" pitchFamily="34" charset="0"/>
                </a:rPr>
                <a:t>OFD1</a:t>
              </a:r>
            </a:p>
          </p:txBody>
        </p:sp>
        <p:pic>
          <p:nvPicPr>
            <p:cNvPr id="52" name="Immagine 51">
              <a:extLst>
                <a:ext uri="{FF2B5EF4-FFF2-40B4-BE49-F238E27FC236}">
                  <a16:creationId xmlns:a16="http://schemas.microsoft.com/office/drawing/2014/main" id="{0CD11263-C704-40E8-84EC-64DDC5E7084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r="1619"/>
            <a:stretch/>
          </p:blipFill>
          <p:spPr>
            <a:xfrm>
              <a:off x="6731502" y="2709785"/>
              <a:ext cx="2412962" cy="1326081"/>
            </a:xfrm>
            <a:prstGeom prst="rect">
              <a:avLst/>
            </a:prstGeom>
          </p:spPr>
        </p:pic>
        <p:sp>
          <p:nvSpPr>
            <p:cNvPr id="35" name="Rettangolo 34">
              <a:extLst>
                <a:ext uri="{FF2B5EF4-FFF2-40B4-BE49-F238E27FC236}">
                  <a16:creationId xmlns:a16="http://schemas.microsoft.com/office/drawing/2014/main" id="{DD780F15-943B-4347-B223-1DE18C9EBA2A}"/>
                </a:ext>
              </a:extLst>
            </p:cNvPr>
            <p:cNvSpPr/>
            <p:nvPr/>
          </p:nvSpPr>
          <p:spPr>
            <a:xfrm>
              <a:off x="7171191" y="1519315"/>
              <a:ext cx="1686145" cy="29843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8" name="Rettangolo 37">
              <a:extLst>
                <a:ext uri="{FF2B5EF4-FFF2-40B4-BE49-F238E27FC236}">
                  <a16:creationId xmlns:a16="http://schemas.microsoft.com/office/drawing/2014/main" id="{5C29597D-3FF2-8343-9860-69130CEF87FC}"/>
                </a:ext>
              </a:extLst>
            </p:cNvPr>
            <p:cNvSpPr/>
            <p:nvPr/>
          </p:nvSpPr>
          <p:spPr>
            <a:xfrm>
              <a:off x="7113600" y="2161306"/>
              <a:ext cx="1620000" cy="29843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9" name="Rettangolo 38">
              <a:extLst>
                <a:ext uri="{FF2B5EF4-FFF2-40B4-BE49-F238E27FC236}">
                  <a16:creationId xmlns:a16="http://schemas.microsoft.com/office/drawing/2014/main" id="{59E73953-FF1C-3F45-A92C-1CDC2FF5B503}"/>
                </a:ext>
              </a:extLst>
            </p:cNvPr>
            <p:cNvSpPr/>
            <p:nvPr/>
          </p:nvSpPr>
          <p:spPr>
            <a:xfrm>
              <a:off x="7078151" y="2721386"/>
              <a:ext cx="1733340" cy="298438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</p:spTree>
    <p:extLst>
      <p:ext uri="{BB962C8B-B14F-4D97-AF65-F5344CB8AC3E}">
        <p14:creationId xmlns:p14="http://schemas.microsoft.com/office/powerpoint/2010/main" val="333322729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28</Words>
  <Application>Microsoft Macintosh PowerPoint</Application>
  <PresentationFormat>Widescreen</PresentationFormat>
  <Paragraphs>17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icrosoft Office User</dc:creator>
  <cp:lastModifiedBy>Microsoft Office User</cp:lastModifiedBy>
  <cp:revision>3</cp:revision>
  <dcterms:created xsi:type="dcterms:W3CDTF">2020-12-20T09:48:30Z</dcterms:created>
  <dcterms:modified xsi:type="dcterms:W3CDTF">2020-12-21T14:00:00Z</dcterms:modified>
</cp:coreProperties>
</file>